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ags/tag65.xml" ContentType="application/vnd.openxmlformats-officedocument.presentationml.tag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2" r:id="rId2"/>
    <p:sldId id="268" r:id="rId3"/>
  </p:sldIdLst>
  <p:sldSz cx="9601200" cy="12801600" type="A3"/>
  <p:notesSz cx="6735763" cy="9866313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52" userDrawn="1">
          <p15:clr>
            <a:srgbClr val="A4A3A4"/>
          </p15:clr>
        </p15:guide>
        <p15:guide id="2" pos="314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3884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3640" y="144"/>
      </p:cViewPr>
      <p:guideLst>
        <p:guide orient="horz" pos="4052"/>
        <p:guide pos="3142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s\Desktop\area%20siz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s\Desktop\Ins%20Glu%20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s\Desktop\Ins%20Glu%20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  <a:sp3d contourW="12700"/>
          </c:spPr>
          <c:invertIfNegative val="0"/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 w="12700">
                <a:solidFill>
                  <a:schemeClr val="tx1"/>
                </a:solidFill>
              </a:ln>
              <a:effectLst/>
              <a:sp3d contourW="12700"/>
            </c:spPr>
            <c:extLst>
              <c:ext xmlns:c16="http://schemas.microsoft.com/office/drawing/2014/chart" uri="{C3380CC4-5D6E-409C-BE32-E72D297353CC}">
                <c16:uniqueId val="{00000001-30AA-C244-8E64-14A926894430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K$71:$L$71</c:f>
                <c:numCache>
                  <c:formatCode>General</c:formatCode>
                  <c:ptCount val="2"/>
                  <c:pt idx="0">
                    <c:v>5.0931444445777698</c:v>
                  </c:pt>
                  <c:pt idx="1">
                    <c:v>3.1252812673421899</c:v>
                  </c:pt>
                </c:numCache>
              </c:numRef>
            </c:plus>
            <c:minus>
              <c:numRef>
                <c:f>Sheet1!$K$71:$L$71</c:f>
                <c:numCache>
                  <c:formatCode>General</c:formatCode>
                  <c:ptCount val="2"/>
                  <c:pt idx="0">
                    <c:v>5.0931444445777698</c:v>
                  </c:pt>
                  <c:pt idx="1">
                    <c:v>3.12528126734218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K$68:$L$68</c:f>
              <c:strCache>
                <c:ptCount val="2"/>
                <c:pt idx="0">
                  <c:v>Control</c:v>
                </c:pt>
                <c:pt idx="1">
                  <c:v>CDKi</c:v>
                </c:pt>
              </c:strCache>
            </c:strRef>
          </c:cat>
          <c:val>
            <c:numRef>
              <c:f>Sheet1!$K$69:$L$69</c:f>
              <c:numCache>
                <c:formatCode>General</c:formatCode>
                <c:ptCount val="2"/>
                <c:pt idx="0">
                  <c:v>58.115666666666698</c:v>
                </c:pt>
                <c:pt idx="1">
                  <c:v>32.533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0AA-C244-8E64-14A9268944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623597"/>
        <c:axId val="336679218"/>
      </c:barChart>
      <c:catAx>
        <c:axId val="424623597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  <c:crossAx val="336679218"/>
        <c:crosses val="autoZero"/>
        <c:auto val="1"/>
        <c:lblAlgn val="ctr"/>
        <c:lblOffset val="100"/>
        <c:noMultiLvlLbl val="0"/>
      </c:catAx>
      <c:valAx>
        <c:axId val="33667921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/>
                  <a:t>Ratio of multi-layered </a:t>
                </a:r>
                <a:r>
                  <a:rPr lang="en-GB"/>
                  <a:t>area</a:t>
                </a:r>
                <a:r>
                  <a:rPr lang="en-US"/>
                  <a:t> </a:t>
                </a:r>
                <a:r>
                  <a:rPr lang="en-GB"/>
                  <a:t>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mpd="sng">
            <a:solidFill>
              <a:schemeClr val="tx1"/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  <c:crossAx val="42462359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80" b="0" i="1" u="none" strike="noStrike" kern="1200" spc="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r>
              <a:rPr lang="en-US" i="1"/>
              <a:t>INSULI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80" b="0" i="1" u="none" strike="noStrike" kern="1200" spc="0" baseline="0">
              <a:solidFill>
                <a:schemeClr val="tx2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  <a:sp3d contourW="12700"/>
          </c:spPr>
          <c:invertIfNegative val="0"/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 w="12700">
                <a:solidFill>
                  <a:schemeClr val="tx1"/>
                </a:solidFill>
              </a:ln>
              <a:effectLst/>
              <a:sp3d contourW="12700"/>
            </c:spPr>
            <c:extLst>
              <c:ext xmlns:c16="http://schemas.microsoft.com/office/drawing/2014/chart" uri="{C3380CC4-5D6E-409C-BE32-E72D297353CC}">
                <c16:uniqueId val="{00000001-9C56-7A47-97B5-3B3498CC1E93}"/>
              </c:ext>
            </c:extLst>
          </c:dPt>
          <c:errBars>
            <c:errBarType val="both"/>
            <c:errValType val="cust"/>
            <c:noEndCap val="0"/>
            <c:plus>
              <c:numRef>
                <c:f>'[Ins Glu 1.xlsx]Sheet1'!$F$21:$G$21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57134630970411804</c:v>
                  </c:pt>
                </c:numCache>
              </c:numRef>
            </c:plus>
            <c:minus>
              <c:numRef>
                <c:f>'[Ins Glu 1.xlsx]Sheet1'!$F$21:$G$21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5713463097041180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Ins Glu 1.xlsx]Sheet1'!$F$18:$G$18</c:f>
              <c:strCache>
                <c:ptCount val="2"/>
                <c:pt idx="0">
                  <c:v>Control</c:v>
                </c:pt>
                <c:pt idx="1">
                  <c:v>CDKi</c:v>
                </c:pt>
              </c:strCache>
            </c:strRef>
          </c:cat>
          <c:val>
            <c:numRef>
              <c:f>'[Ins Glu 1.xlsx]Sheet1'!$F$19:$G$19</c:f>
              <c:numCache>
                <c:formatCode>General</c:formatCode>
                <c:ptCount val="2"/>
                <c:pt idx="0">
                  <c:v>1</c:v>
                </c:pt>
                <c:pt idx="1">
                  <c:v>2.7380202829160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56-7A47-97B5-3B3498CC1E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2754151"/>
        <c:axId val="513396677"/>
      </c:barChart>
      <c:catAx>
        <c:axId val="532754151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13396677"/>
        <c:crosses val="autoZero"/>
        <c:auto val="1"/>
        <c:lblAlgn val="ctr"/>
        <c:lblOffset val="100"/>
        <c:noMultiLvlLbl val="0"/>
      </c:catAx>
      <c:valAx>
        <c:axId val="51339667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Relative ratio change (/Contro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2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327541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solidFill>
        <a:schemeClr val="accent1"/>
      </a:solidFill>
      <a:round/>
    </a:ln>
    <a:effectLst/>
  </c:spPr>
  <c:txPr>
    <a:bodyPr/>
    <a:lstStyle/>
    <a:p>
      <a:pPr>
        <a:defRPr lang="zh-CN" sz="1400">
          <a:solidFill>
            <a:schemeClr val="tx2"/>
          </a:solidFill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80" b="0" i="1" u="none" strike="noStrike" kern="1200" spc="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r>
              <a:rPr lang="en-US" i="1"/>
              <a:t>GLUCAG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80" b="0" i="1" u="none" strike="noStrike" kern="1200" spc="0" baseline="0">
              <a:solidFill>
                <a:schemeClr val="tx2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  <a:sp3d contourW="12700"/>
          </c:spPr>
          <c:invertIfNegative val="0"/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 w="12700">
                <a:solidFill>
                  <a:schemeClr val="tx1"/>
                </a:solidFill>
              </a:ln>
              <a:effectLst/>
              <a:sp3d contourW="12700"/>
            </c:spPr>
            <c:extLst>
              <c:ext xmlns:c16="http://schemas.microsoft.com/office/drawing/2014/chart" uri="{C3380CC4-5D6E-409C-BE32-E72D297353CC}">
                <c16:uniqueId val="{00000001-5E1C-FB44-8B77-0283325492B9}"/>
              </c:ext>
            </c:extLst>
          </c:dPt>
          <c:errBars>
            <c:errBarType val="both"/>
            <c:errValType val="cust"/>
            <c:noEndCap val="0"/>
            <c:plus>
              <c:numRef>
                <c:f>'[Ins Glu 1.xlsx]Sheet1'!$G$33:$H$3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.303479761483</c:v>
                  </c:pt>
                </c:numCache>
              </c:numRef>
            </c:plus>
            <c:minus>
              <c:numRef>
                <c:f>'[Ins Glu 1.xlsx]Sheet1'!$G$33:$H$3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.30347976148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Ins Glu 1.xlsx]Sheet1'!$G$30:$H$30</c:f>
              <c:strCache>
                <c:ptCount val="2"/>
                <c:pt idx="0">
                  <c:v>Control</c:v>
                </c:pt>
                <c:pt idx="1">
                  <c:v>CDKi</c:v>
                </c:pt>
              </c:strCache>
            </c:strRef>
          </c:cat>
          <c:val>
            <c:numRef>
              <c:f>'[Ins Glu 1.xlsx]Sheet1'!$G$31:$H$31</c:f>
              <c:numCache>
                <c:formatCode>General</c:formatCode>
                <c:ptCount val="2"/>
                <c:pt idx="0">
                  <c:v>1</c:v>
                </c:pt>
                <c:pt idx="1">
                  <c:v>6.7897931455483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1C-FB44-8B77-0283325492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6977575"/>
        <c:axId val="579182961"/>
      </c:barChart>
      <c:catAx>
        <c:axId val="506977575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79182961"/>
        <c:crosses val="autoZero"/>
        <c:auto val="1"/>
        <c:lblAlgn val="ctr"/>
        <c:lblOffset val="100"/>
        <c:noMultiLvlLbl val="0"/>
      </c:catAx>
      <c:valAx>
        <c:axId val="57918296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Relative ratio change (/Contro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069775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solidFill>
        <a:schemeClr val="accent1"/>
      </a:solidFill>
      <a:round/>
    </a:ln>
    <a:effectLst/>
  </c:spPr>
  <c:txPr>
    <a:bodyPr/>
    <a:lstStyle/>
    <a:p>
      <a:pPr>
        <a:defRPr lang="zh-CN" sz="1400">
          <a:solidFill>
            <a:schemeClr val="tx2"/>
          </a:solidFill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39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zh-CN" dirty="0"/>
              <a:t>IHC: positive Cell ratio</a:t>
            </a:r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4612A2-B741-394D-937A-50CB029F27D8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944055" y="1706880"/>
            <a:ext cx="7716870" cy="479808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3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944055" y="6646081"/>
            <a:ext cx="7716870" cy="274848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520" spc="20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79115" y="1444800"/>
            <a:ext cx="8641080" cy="1023456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944055" y="4636800"/>
            <a:ext cx="7716870" cy="190176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3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944055" y="6646081"/>
            <a:ext cx="7716870" cy="88032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52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79115" y="1135680"/>
            <a:ext cx="8638245" cy="13171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479115" y="2782080"/>
            <a:ext cx="8638245" cy="888384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567755" y="7183681"/>
            <a:ext cx="6117930" cy="143136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62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567755" y="8615041"/>
            <a:ext cx="6117930" cy="161952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9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800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79115" y="1135680"/>
            <a:ext cx="8638245" cy="13171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479115" y="2802240"/>
            <a:ext cx="4076730" cy="886368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5049135" y="2802240"/>
            <a:ext cx="4076730" cy="8863681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79115" y="1135680"/>
            <a:ext cx="8638245" cy="13171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479115" y="2667840"/>
            <a:ext cx="4207140" cy="71232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1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79115" y="3460800"/>
            <a:ext cx="4207140" cy="8205121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4910653" y="2653894"/>
            <a:ext cx="4207140" cy="71232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1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4910653" y="3460800"/>
            <a:ext cx="4207140" cy="8205121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79115" y="1135680"/>
            <a:ext cx="8638245" cy="131712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79115" y="2903040"/>
            <a:ext cx="4121048" cy="860160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8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5000940" y="2903040"/>
            <a:ext cx="4116420" cy="860160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8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5/17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8059905" y="1706880"/>
            <a:ext cx="822150" cy="9387841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94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720090" y="1706880"/>
            <a:ext cx="7220745" cy="9387841"/>
          </a:xfrm>
        </p:spPr>
        <p:txBody>
          <a:bodyPr vert="eaVert" lIns="46800" tIns="46800" rIns="46800" bIns="46800"/>
          <a:lstStyle>
            <a:lvl1pPr marL="240030" indent="-240030">
              <a:spcAft>
                <a:spcPts val="1000"/>
              </a:spcAft>
              <a:defRPr spc="300"/>
            </a:lvl1pPr>
            <a:lvl2pPr marL="720090" indent="-240030">
              <a:defRPr spc="300"/>
            </a:lvl2pPr>
            <a:lvl3pPr marL="1200150" indent="-240030">
              <a:defRPr spc="300"/>
            </a:lvl3pPr>
            <a:lvl4pPr marL="1680210" indent="-240030">
              <a:defRPr spc="300"/>
            </a:lvl4pPr>
            <a:lvl5pPr marL="2160270" indent="-24003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79115" y="1135680"/>
            <a:ext cx="8638245" cy="131712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79115" y="2782080"/>
            <a:ext cx="8638245" cy="8883841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81950" y="11786881"/>
            <a:ext cx="2126250" cy="5913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5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241350" y="11786881"/>
            <a:ext cx="3118500" cy="5913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991110" y="11786881"/>
            <a:ext cx="2126250" cy="5913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60120" rtl="0" eaLnBrk="1" fontAlgn="auto" latinLnBrk="0" hangingPunct="1">
        <a:lnSpc>
          <a:spcPct val="100000"/>
        </a:lnSpc>
        <a:spcBef>
          <a:spcPct val="0"/>
        </a:spcBef>
        <a:buNone/>
        <a:defRPr sz="378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9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720090" indent="-240030" algn="l" defTabSz="96012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90370" algn="l"/>
          <a:tab pos="1690370" algn="l"/>
          <a:tab pos="1690370" algn="l"/>
          <a:tab pos="1690370" algn="l"/>
        </a:tabLst>
        <a:defRPr sz="168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200150" indent="-240030" algn="l" defTabSz="96012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8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80210" indent="-240030" algn="l" defTabSz="96012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7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160270" indent="-240030" algn="l" defTabSz="96012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7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.tiff"/><Relationship Id="rId12" Type="http://schemas.openxmlformats.org/officeDocument/2006/relationships/image" Target="../media/image8.tif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Relationship Id="rId6" Type="http://schemas.openxmlformats.org/officeDocument/2006/relationships/image" Target="../media/image2.tiff"/><Relationship Id="rId11" Type="http://schemas.openxmlformats.org/officeDocument/2006/relationships/image" Target="../media/image7.tiff"/><Relationship Id="rId5" Type="http://schemas.openxmlformats.org/officeDocument/2006/relationships/image" Target="../media/image1.tiff"/><Relationship Id="rId10" Type="http://schemas.openxmlformats.org/officeDocument/2006/relationships/image" Target="../media/image6.tiff"/><Relationship Id="rId4" Type="http://schemas.openxmlformats.org/officeDocument/2006/relationships/chart" Target="../charts/chart1.xml"/><Relationship Id="rId9" Type="http://schemas.openxmlformats.org/officeDocument/2006/relationships/image" Target="../media/image5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5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/>
        </p:nvSpPr>
        <p:spPr>
          <a:xfrm>
            <a:off x="716280" y="248180"/>
            <a:ext cx="8168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+mj-lt"/>
                <a:cs typeface="Arial" panose="020B0604020202020204" pitchFamily="34" charset="0"/>
              </a:rPr>
              <a:t>Supplemental Figure 1 (Ning et al.)</a:t>
            </a:r>
            <a:endParaRPr lang="en-US" altLang="zh-CN" dirty="0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51421" y="1026985"/>
            <a:ext cx="319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+mj-lt"/>
              </a:rPr>
              <a:t>A</a:t>
            </a:r>
            <a:endParaRPr kumimoji="1" lang="zh-CN" altLang="en-US" b="1" dirty="0">
              <a:latin typeface="+mj-lt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7037004" y="1026985"/>
            <a:ext cx="319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+mj-lt"/>
              </a:rPr>
              <a:t>B</a:t>
            </a:r>
            <a:endParaRPr kumimoji="1" lang="zh-CN" altLang="en-US" b="1" dirty="0">
              <a:latin typeface="+mj-lt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194962E-FE6C-06D9-4472-1152AF2A8A2B}"/>
              </a:ext>
            </a:extLst>
          </p:cNvPr>
          <p:cNvSpPr txBox="1"/>
          <p:nvPr/>
        </p:nvSpPr>
        <p:spPr>
          <a:xfrm>
            <a:off x="2798533" y="1268818"/>
            <a:ext cx="9132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PEP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CE114E9-128F-010A-D429-654E8A4299EA}"/>
              </a:ext>
            </a:extLst>
          </p:cNvPr>
          <p:cNvSpPr txBox="1"/>
          <p:nvPr/>
        </p:nvSpPr>
        <p:spPr>
          <a:xfrm>
            <a:off x="5800081" y="1271197"/>
            <a:ext cx="733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B38A5B6-D917-F095-7D9F-333D89B44A02}"/>
              </a:ext>
            </a:extLst>
          </p:cNvPr>
          <p:cNvSpPr txBox="1"/>
          <p:nvPr/>
        </p:nvSpPr>
        <p:spPr>
          <a:xfrm>
            <a:off x="289224" y="3063072"/>
            <a:ext cx="643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i</a:t>
            </a:r>
            <a:endParaRPr lang="en-US" altLang="zh-CN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5BBA7C8-EAFD-2DAB-A04C-EB64F4CC735F}"/>
              </a:ext>
            </a:extLst>
          </p:cNvPr>
          <p:cNvSpPr txBox="1"/>
          <p:nvPr/>
        </p:nvSpPr>
        <p:spPr>
          <a:xfrm>
            <a:off x="1442129" y="1265444"/>
            <a:ext cx="711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U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AE8913C-0A8F-7E04-EB8D-66C259A6C319}"/>
              </a:ext>
            </a:extLst>
          </p:cNvPr>
          <p:cNvSpPr txBox="1"/>
          <p:nvPr/>
        </p:nvSpPr>
        <p:spPr>
          <a:xfrm>
            <a:off x="176713" y="1950235"/>
            <a:ext cx="868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graphicFrame>
        <p:nvGraphicFramePr>
          <p:cNvPr id="45" name="图表 44">
            <a:extLst>
              <a:ext uri="{FF2B5EF4-FFF2-40B4-BE49-F238E27FC236}">
                <a16:creationId xmlns:a16="http://schemas.microsoft.com/office/drawing/2014/main" id="{9324FFD4-918B-4052-1CD9-A3E3F7A9F0D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05300605"/>
              </p:ext>
            </p:extLst>
          </p:nvPr>
        </p:nvGraphicFramePr>
        <p:xfrm>
          <a:off x="7356500" y="1336162"/>
          <a:ext cx="1929646" cy="2823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60" name="直接连接符 12">
            <a:extLst>
              <a:ext uri="{FF2B5EF4-FFF2-40B4-BE49-F238E27FC236}">
                <a16:creationId xmlns:a16="http://schemas.microsoft.com/office/drawing/2014/main" id="{811535F3-B309-EC38-1E87-D64D6F3FFA7F}"/>
              </a:ext>
            </a:extLst>
          </p:cNvPr>
          <p:cNvCxnSpPr>
            <a:cxnSpLocks/>
          </p:cNvCxnSpPr>
          <p:nvPr/>
        </p:nvCxnSpPr>
        <p:spPr>
          <a:xfrm>
            <a:off x="8299486" y="1558983"/>
            <a:ext cx="5879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2FBB9364-2806-3FE5-BD33-77E07B17EC5E}"/>
              </a:ext>
            </a:extLst>
          </p:cNvPr>
          <p:cNvSpPr txBox="1"/>
          <p:nvPr/>
        </p:nvSpPr>
        <p:spPr>
          <a:xfrm>
            <a:off x="8358494" y="1332430"/>
            <a:ext cx="469900" cy="2203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ECC1DCC9-C575-08F8-0E18-EC311152E21B}"/>
              </a:ext>
            </a:extLst>
          </p:cNvPr>
          <p:cNvSpPr txBox="1"/>
          <p:nvPr/>
        </p:nvSpPr>
        <p:spPr>
          <a:xfrm>
            <a:off x="4385168" y="1271071"/>
            <a:ext cx="693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70" name="图片 69" descr="Composite (RGB)">
            <a:extLst>
              <a:ext uri="{FF2B5EF4-FFF2-40B4-BE49-F238E27FC236}">
                <a16:creationId xmlns:a16="http://schemas.microsoft.com/office/drawing/2014/main" id="{9C507107-8702-1BC8-C037-D4037A8E12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50249" y="1564124"/>
            <a:ext cx="1439145" cy="1080000"/>
          </a:xfrm>
          <a:prstGeom prst="rect">
            <a:avLst/>
          </a:prstGeom>
        </p:spPr>
      </p:pic>
      <p:pic>
        <p:nvPicPr>
          <p:cNvPr id="71" name="图片 70" descr="g2">
            <a:extLst>
              <a:ext uri="{FF2B5EF4-FFF2-40B4-BE49-F238E27FC236}">
                <a16:creationId xmlns:a16="http://schemas.microsoft.com/office/drawing/2014/main" id="{30E1D75C-8231-97A0-403A-270A593872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78274" y="1564124"/>
            <a:ext cx="1439145" cy="1080000"/>
          </a:xfrm>
          <a:prstGeom prst="rect">
            <a:avLst/>
          </a:prstGeom>
        </p:spPr>
      </p:pic>
      <p:pic>
        <p:nvPicPr>
          <p:cNvPr id="72" name="图片 71" descr="r2">
            <a:extLst>
              <a:ext uri="{FF2B5EF4-FFF2-40B4-BE49-F238E27FC236}">
                <a16:creationId xmlns:a16="http://schemas.microsoft.com/office/drawing/2014/main" id="{D40CC135-6ED6-CCC4-07A3-F455730D188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35599" y="1564124"/>
            <a:ext cx="1439145" cy="1080000"/>
          </a:xfrm>
          <a:prstGeom prst="rect">
            <a:avLst/>
          </a:prstGeom>
        </p:spPr>
      </p:pic>
      <p:pic>
        <p:nvPicPr>
          <p:cNvPr id="73" name="图片 72" descr="b2">
            <a:extLst>
              <a:ext uri="{FF2B5EF4-FFF2-40B4-BE49-F238E27FC236}">
                <a16:creationId xmlns:a16="http://schemas.microsoft.com/office/drawing/2014/main" id="{66AFB4D2-5D86-B1C1-3CC8-85D32AFE0FB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91019" y="1564124"/>
            <a:ext cx="1439145" cy="1080000"/>
          </a:xfrm>
          <a:prstGeom prst="rect">
            <a:avLst/>
          </a:prstGeom>
        </p:spPr>
      </p:pic>
      <p:pic>
        <p:nvPicPr>
          <p:cNvPr id="74" name="图片 73" descr="b2">
            <a:extLst>
              <a:ext uri="{FF2B5EF4-FFF2-40B4-BE49-F238E27FC236}">
                <a16:creationId xmlns:a16="http://schemas.microsoft.com/office/drawing/2014/main" id="{B4AE3DE1-DB62-295F-DA90-AE2E75D2268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91019" y="2676961"/>
            <a:ext cx="1439145" cy="1080000"/>
          </a:xfrm>
          <a:prstGeom prst="rect">
            <a:avLst/>
          </a:prstGeom>
        </p:spPr>
      </p:pic>
      <p:pic>
        <p:nvPicPr>
          <p:cNvPr id="75" name="图片 74" descr="Composite (RGB)-1">
            <a:extLst>
              <a:ext uri="{FF2B5EF4-FFF2-40B4-BE49-F238E27FC236}">
                <a16:creationId xmlns:a16="http://schemas.microsoft.com/office/drawing/2014/main" id="{C382BFB3-4F10-FD22-BA38-F75A9E6EB00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450249" y="2676961"/>
            <a:ext cx="1439145" cy="1080000"/>
          </a:xfrm>
          <a:prstGeom prst="rect">
            <a:avLst/>
          </a:prstGeom>
        </p:spPr>
      </p:pic>
      <p:pic>
        <p:nvPicPr>
          <p:cNvPr id="76" name="图片 75" descr="g2">
            <a:extLst>
              <a:ext uri="{FF2B5EF4-FFF2-40B4-BE49-F238E27FC236}">
                <a16:creationId xmlns:a16="http://schemas.microsoft.com/office/drawing/2014/main" id="{6F928EE3-AE50-24B4-8D76-54531811569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78274" y="2676961"/>
            <a:ext cx="1439145" cy="1080000"/>
          </a:xfrm>
          <a:prstGeom prst="rect">
            <a:avLst/>
          </a:prstGeom>
        </p:spPr>
      </p:pic>
      <p:pic>
        <p:nvPicPr>
          <p:cNvPr id="77" name="图片 76" descr="r2">
            <a:extLst>
              <a:ext uri="{FF2B5EF4-FFF2-40B4-BE49-F238E27FC236}">
                <a16:creationId xmlns:a16="http://schemas.microsoft.com/office/drawing/2014/main" id="{9D7EF213-FCB4-484A-72DC-A76B1C3BC17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35599" y="2676961"/>
            <a:ext cx="1439145" cy="108000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/>
        </p:nvSpPr>
        <p:spPr>
          <a:xfrm>
            <a:off x="232410" y="212725"/>
            <a:ext cx="8942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l Figure 2 (Ning et al.) </a:t>
            </a:r>
            <a:endParaRPr lang="en-US" altLang="zh-CN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图表 3"/>
          <p:cNvGraphicFramePr/>
          <p:nvPr>
            <p:extLst>
              <p:ext uri="{D42A27DB-BD31-4B8C-83A1-F6EECF244321}">
                <p14:modId xmlns:p14="http://schemas.microsoft.com/office/powerpoint/2010/main" val="491890404"/>
              </p:ext>
            </p:extLst>
          </p:nvPr>
        </p:nvGraphicFramePr>
        <p:xfrm>
          <a:off x="674370" y="981709"/>
          <a:ext cx="2560501" cy="3329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7" name="直接连接符 26"/>
          <p:cNvCxnSpPr>
            <a:cxnSpLocks/>
          </p:cNvCxnSpPr>
          <p:nvPr/>
        </p:nvCxnSpPr>
        <p:spPr>
          <a:xfrm flipV="1">
            <a:off x="1906270" y="1540063"/>
            <a:ext cx="7835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>
            <a:off x="2129767" y="1295315"/>
            <a:ext cx="336550" cy="2203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232109" y="881681"/>
            <a:ext cx="319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A</a:t>
            </a:r>
            <a:endParaRPr kumimoji="1" lang="zh-CN" altLang="en-US" b="1" dirty="0"/>
          </a:p>
        </p:txBody>
      </p:sp>
      <p:graphicFrame>
        <p:nvGraphicFramePr>
          <p:cNvPr id="7" name="图表 6"/>
          <p:cNvGraphicFramePr/>
          <p:nvPr>
            <p:extLst>
              <p:ext uri="{D42A27DB-BD31-4B8C-83A1-F6EECF244321}">
                <p14:modId xmlns:p14="http://schemas.microsoft.com/office/powerpoint/2010/main" val="1801961057"/>
              </p:ext>
            </p:extLst>
          </p:nvPr>
        </p:nvGraphicFramePr>
        <p:xfrm>
          <a:off x="3911239" y="991206"/>
          <a:ext cx="2560501" cy="3319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5343683" y="1406717"/>
            <a:ext cx="336550" cy="2203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3076165" y="904478"/>
            <a:ext cx="319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B</a:t>
            </a:r>
            <a:endParaRPr kumimoji="1" lang="zh-CN" altLang="en-US" b="1" dirty="0"/>
          </a:p>
        </p:txBody>
      </p:sp>
      <p:cxnSp>
        <p:nvCxnSpPr>
          <p:cNvPr id="6" name="直接连接符 26">
            <a:extLst>
              <a:ext uri="{FF2B5EF4-FFF2-40B4-BE49-F238E27FC236}">
                <a16:creationId xmlns:a16="http://schemas.microsoft.com/office/drawing/2014/main" id="{5A60DA33-A932-D6B4-A0AA-EADEED9151D1}"/>
              </a:ext>
            </a:extLst>
          </p:cNvPr>
          <p:cNvCxnSpPr>
            <a:cxnSpLocks/>
          </p:cNvCxnSpPr>
          <p:nvPr/>
        </p:nvCxnSpPr>
        <p:spPr>
          <a:xfrm flipV="1">
            <a:off x="5120186" y="1650235"/>
            <a:ext cx="7835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jI3YmIxZmIxMTQ3MDEzMjBhMTViNjQwMTUwMTEwZmQifQ=="/>
  <p:tag name="KSO_WPP_MARK_KEY" val="c3a9f7be-83c1-4b99-85f3-882e29a0e7b3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57</TotalTime>
  <Words>54</Words>
  <Application>Microsoft Macintosh PowerPoint</Application>
  <PresentationFormat>A3 纸张(297x420 毫米)</PresentationFormat>
  <Paragraphs>22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Wingdings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寧　鶴鳴</cp:lastModifiedBy>
  <cp:revision>290</cp:revision>
  <dcterms:created xsi:type="dcterms:W3CDTF">2019-06-19T02:08:00Z</dcterms:created>
  <dcterms:modified xsi:type="dcterms:W3CDTF">2023-05-17T03:1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703</vt:lpwstr>
  </property>
  <property fmtid="{D5CDD505-2E9C-101B-9397-08002B2CF9AE}" pid="3" name="ICV">
    <vt:lpwstr>2416BEEF456245EBA5E024EDA8237350</vt:lpwstr>
  </property>
</Properties>
</file>